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12192000" cy="6858000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6014" autoAdjust="0"/>
    <p:restoredTop sz="93447" autoAdjust="0"/>
  </p:normalViewPr>
  <p:slideViewPr>
    <p:cSldViewPr snapToGrid="0">
      <p:cViewPr varScale="1">
        <p:scale>
          <a:sx n="107" d="100"/>
          <a:sy n="107" d="100"/>
        </p:scale>
        <p:origin x="120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34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34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878891-3B70-4B94-BAEE-88FEB18586E5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54113"/>
            <a:ext cx="5540375" cy="31162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44861"/>
            <a:ext cx="5608320" cy="363670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34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340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97DE3F-8F04-476B-AF8E-D0D1D2CF36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3762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897DE3F-8F04-476B-AF8E-D0D1D2CF36A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5909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ECF64-62E6-4B8E-90D5-84029C0D69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EFC55DB-270A-FE06-C0C2-8C3B7960E0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36E5E1-EFE0-D916-EE58-848BFE985C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624415-F5A9-5098-5E2E-9C05872486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45B319-3B47-4B86-1939-2395AC0E0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070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A48B98-5F78-5FAE-F487-932D8CDB55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050F19-B690-1C98-4C97-C2EB701659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47D955-E84D-DA92-71E0-19983DE7EE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EE7442-0FA0-0662-4880-EB70B5A386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A60A8C-DACC-C25D-EA31-228637473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473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AFAA582-80EA-8FFE-6717-8F7660FD22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06AB09-1D1B-598A-3196-87DE1F9B81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1D5950-191C-D2E6-3974-A35C46151C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E24EE5-9452-84DF-1A7F-3D2E1C52C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4FCC4B-8E7D-2B5D-0791-B950B7622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699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7103AE-2CA8-D316-AFE5-E63ABEA098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C24A61-629B-67A4-921D-8E595D3372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1DC599-085D-F352-6523-1CE8CB325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056BCE-8FDD-DC7C-BFA2-646FCFD7F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0E68B1-7026-6D9A-AA6F-86D5A2244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700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159DE-46C7-7112-D8F4-AC0846F4D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C751615-850B-8EE3-CD07-A41BCC96B0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6D6D35-6EEE-76CB-A7B3-9393C6285B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E1BD30-B32D-92E3-8943-51DD5C005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903268-9725-9EEB-4396-3DC7FE27B9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064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8EA0BF-849F-9564-DDCD-9D6E2F52E8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B608DA-F013-88F9-DECC-12F3D99742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B9CD44-76E8-EB8B-4F78-D717428AF9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3A4DA9-3BC5-6799-6BA0-C4C1991711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050E6D9-1A18-C6B4-92F5-CFF5A6A40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A9BB7A-3135-2BF6-6401-D24789835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824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2FAC7F-C16F-D8C4-3D2E-AD085291B3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FF2890-2C17-37FD-0A84-F3892166DD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05EA2C-667E-3AB7-E26B-8A78C667B4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F41096-C25D-2831-01D7-2D3B934545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951FEE-E9E0-6A8E-CE16-01F17AD753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5F7DA7-B82C-D8DB-4CB6-A2EBB76DA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4914E22-4792-AF32-96EE-BA1F85350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12D419-4CC5-FE70-6BE4-A530667D1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92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66F74C-1488-E29C-0EF7-29815B736E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A1B1ADC-5E07-A38D-9B4D-54BDEEA37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D3A60B-1623-0F7E-17FA-23C909281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73969C3-F1A5-90A5-D54E-E6258A2D4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612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51E7637-6E7A-283C-6283-60359DF8E8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E4978E-B117-9941-29EC-A70E0FA980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3FD7E27-B98F-6776-573A-EBACEC9A4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792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CDCCCB-1A48-3A52-BAE1-BFED42D545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934DA0-DFB0-DE2B-9DD5-A6E08348AD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25438A-98D3-6F12-5556-FD99DD4489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FD4AED-5D58-CA1B-FD3F-15506906C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9CB4F1-064F-7EE5-ECD7-3AF181820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6C0817-EA96-463A-7FC5-0238C772B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498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25C869-05BF-9F9A-18D3-0662AB90AA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CA6735-F013-975D-91C3-36205A9383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843637-448B-0412-ED75-BFAC61BA7F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EF5FAF-7C11-BCAF-C5F7-9DB8DF122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637007-F46F-052B-F5EC-2C05A50B9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9C9CED-02A8-286D-37DD-8F866DB23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831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D47AEBF-16CF-0A62-F011-6A11A4E99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01EB9A-1BFA-5855-3D70-BBE95E170F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F12A36-4D3F-6E80-E41F-79314E9200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00D2AE-1854-4865-8E28-7F0D0DB748FF}" type="datetimeFigureOut">
              <a:rPr lang="en-US" smtClean="0"/>
              <a:t>10/21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49328-9A8E-A056-517B-F9FD5B9D88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80532B-B214-6D1B-94CE-81305ED7AB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881D2E-E029-4622-A508-9B9C13E12A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233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F2A8F24-AD5B-642A-4223-458D350B7514}"/>
              </a:ext>
            </a:extLst>
          </p:cNvPr>
          <p:cNvGrpSpPr/>
          <p:nvPr/>
        </p:nvGrpSpPr>
        <p:grpSpPr>
          <a:xfrm>
            <a:off x="96784" y="1956561"/>
            <a:ext cx="10788898" cy="3892909"/>
            <a:chOff x="225081" y="1518451"/>
            <a:chExt cx="6837870" cy="2467278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09E324E1-79C7-2024-4E1D-3F9234480886}"/>
                </a:ext>
              </a:extLst>
            </p:cNvPr>
            <p:cNvGrpSpPr/>
            <p:nvPr/>
          </p:nvGrpSpPr>
          <p:grpSpPr>
            <a:xfrm>
              <a:off x="225081" y="1518451"/>
              <a:ext cx="6837870" cy="2071673"/>
              <a:chOff x="1809193" y="1133272"/>
              <a:chExt cx="8303667" cy="2515766"/>
            </a:xfrm>
          </p:grpSpPr>
          <p:pic>
            <p:nvPicPr>
              <p:cNvPr id="7" name="Picture 6" descr="A crossword puzzle with many squares&#10;&#10;Description automatically generated">
                <a:extLst>
                  <a:ext uri="{FF2B5EF4-FFF2-40B4-BE49-F238E27FC236}">
                    <a16:creationId xmlns:a16="http://schemas.microsoft.com/office/drawing/2014/main" id="{4A50E402-6AA4-94F6-C4CA-32B06B2ACFC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5179" b="17027"/>
              <a:stretch/>
            </p:blipFill>
            <p:spPr>
              <a:xfrm>
                <a:off x="3741078" y="1133272"/>
                <a:ext cx="6371782" cy="2509021"/>
              </a:xfrm>
              <a:prstGeom prst="rect">
                <a:avLst/>
              </a:prstGeom>
            </p:spPr>
          </p:pic>
          <p:pic>
            <p:nvPicPr>
              <p:cNvPr id="8" name="Picture 7" descr="A graph with different colored squares&#10;&#10;Description automatically generated">
                <a:extLst>
                  <a:ext uri="{FF2B5EF4-FFF2-40B4-BE49-F238E27FC236}">
                    <a16:creationId xmlns:a16="http://schemas.microsoft.com/office/drawing/2014/main" id="{77AD3C3A-7A4A-0AA3-C078-493273C8D8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9559"/>
              <a:stretch/>
            </p:blipFill>
            <p:spPr>
              <a:xfrm>
                <a:off x="1809193" y="1175982"/>
                <a:ext cx="1989354" cy="2473056"/>
              </a:xfrm>
              <a:prstGeom prst="rect">
                <a:avLst/>
              </a:prstGeom>
            </p:spPr>
          </p:pic>
        </p:grpSp>
        <p:pic>
          <p:nvPicPr>
            <p:cNvPr id="6" name="Picture 5" descr="A graph of different colored squares&#10;&#10;Description automatically generated">
              <a:extLst>
                <a:ext uri="{FF2B5EF4-FFF2-40B4-BE49-F238E27FC236}">
                  <a16:creationId xmlns:a16="http://schemas.microsoft.com/office/drawing/2014/main" id="{160A9D9D-5864-6D38-4D39-332CE9CAE0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1391" t="89966" r="20994" b="1182"/>
            <a:stretch/>
          </p:blipFill>
          <p:spPr>
            <a:xfrm>
              <a:off x="318830" y="3687863"/>
              <a:ext cx="3489317" cy="297866"/>
            </a:xfrm>
            <a:prstGeom prst="rect">
              <a:avLst/>
            </a:prstGeom>
          </p:spPr>
        </p:pic>
      </p:grpSp>
      <p:pic>
        <p:nvPicPr>
          <p:cNvPr id="9" name="Picture 8" descr="A chart of different colored bars&#10;&#10;Description automatically generated">
            <a:extLst>
              <a:ext uri="{FF2B5EF4-FFF2-40B4-BE49-F238E27FC236}">
                <a16:creationId xmlns:a16="http://schemas.microsoft.com/office/drawing/2014/main" id="{8793D122-4AC5-B33F-6E0B-58640530A37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2638" t="30092" r="5444" b="44440"/>
          <a:stretch/>
        </p:blipFill>
        <p:spPr>
          <a:xfrm>
            <a:off x="10657082" y="3029783"/>
            <a:ext cx="1534918" cy="172244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0027898F-38B1-371B-F748-2D1C5BC6BD3A}"/>
              </a:ext>
            </a:extLst>
          </p:cNvPr>
          <p:cNvSpPr txBox="1"/>
          <p:nvPr/>
        </p:nvSpPr>
        <p:spPr>
          <a:xfrm>
            <a:off x="3665616" y="606151"/>
            <a:ext cx="5647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istribution of top variants across molecular subtype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A67C33E-D2C4-BE87-C451-173615F2B231}"/>
              </a:ext>
            </a:extLst>
          </p:cNvPr>
          <p:cNvSpPr txBox="1"/>
          <p:nvPr/>
        </p:nvSpPr>
        <p:spPr>
          <a:xfrm>
            <a:off x="331694" y="6311153"/>
            <a:ext cx="115913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2. Summary of genomic solid tissue results</a:t>
            </a:r>
            <a:r>
              <a:rPr lang="en-US" sz="9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.  MSK-IMPACT mutation profiling results in treatment-naive solid tissues obtained at diagnosis.  Molecular subtyping results are shown based on transcriptomic profiling using the BC360 results. Progression status refers to progression cut-off at 3 months. Bar plot colors indicate variant classification.</a:t>
            </a:r>
            <a:endParaRPr lang="en-US" sz="9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475808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47</TotalTime>
  <Words>62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Bayani</dc:creator>
  <cp:lastModifiedBy>Quann, Karen</cp:lastModifiedBy>
  <cp:revision>309</cp:revision>
  <cp:lastPrinted>2023-08-16T18:12:39Z</cp:lastPrinted>
  <dcterms:created xsi:type="dcterms:W3CDTF">2023-05-04T15:52:47Z</dcterms:created>
  <dcterms:modified xsi:type="dcterms:W3CDTF">2025-10-21T17:08:14Z</dcterms:modified>
</cp:coreProperties>
</file>